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2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7" d="100"/>
          <a:sy n="87" d="100"/>
        </p:scale>
        <p:origin x="290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52D5-6FFA-4D8B-B3AE-99A61AF316AC}" type="datetimeFigureOut">
              <a:rPr lang="fr-FR" smtClean="0"/>
              <a:t>12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F22-24AF-4B7D-BD22-745835151E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432799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52D5-6FFA-4D8B-B3AE-99A61AF316AC}" type="datetimeFigureOut">
              <a:rPr lang="fr-FR" smtClean="0"/>
              <a:t>12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F22-24AF-4B7D-BD22-745835151E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049408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52D5-6FFA-4D8B-B3AE-99A61AF316AC}" type="datetimeFigureOut">
              <a:rPr lang="fr-FR" smtClean="0"/>
              <a:t>12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F22-24AF-4B7D-BD22-745835151E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9208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52D5-6FFA-4D8B-B3AE-99A61AF316AC}" type="datetimeFigureOut">
              <a:rPr lang="fr-FR" smtClean="0"/>
              <a:t>12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F22-24AF-4B7D-BD22-745835151E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71630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52D5-6FFA-4D8B-B3AE-99A61AF316AC}" type="datetimeFigureOut">
              <a:rPr lang="fr-FR" smtClean="0"/>
              <a:t>12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F22-24AF-4B7D-BD22-745835151E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219650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52D5-6FFA-4D8B-B3AE-99A61AF316AC}" type="datetimeFigureOut">
              <a:rPr lang="fr-FR" smtClean="0"/>
              <a:t>12/08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F22-24AF-4B7D-BD22-745835151E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17545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52D5-6FFA-4D8B-B3AE-99A61AF316AC}" type="datetimeFigureOut">
              <a:rPr lang="fr-FR" smtClean="0"/>
              <a:t>12/08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F22-24AF-4B7D-BD22-745835151E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53793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52D5-6FFA-4D8B-B3AE-99A61AF316AC}" type="datetimeFigureOut">
              <a:rPr lang="fr-FR" smtClean="0"/>
              <a:t>12/08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F22-24AF-4B7D-BD22-745835151E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18431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52D5-6FFA-4D8B-B3AE-99A61AF316AC}" type="datetimeFigureOut">
              <a:rPr lang="fr-FR" smtClean="0"/>
              <a:t>12/08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F22-24AF-4B7D-BD22-745835151E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9623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52D5-6FFA-4D8B-B3AE-99A61AF316AC}" type="datetimeFigureOut">
              <a:rPr lang="fr-FR" smtClean="0"/>
              <a:t>12/08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F22-24AF-4B7D-BD22-745835151E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839520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52D5-6FFA-4D8B-B3AE-99A61AF316AC}" type="datetimeFigureOut">
              <a:rPr lang="fr-FR" smtClean="0"/>
              <a:t>12/08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76F22-24AF-4B7D-BD22-745835151E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4600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5D52D5-6FFA-4D8B-B3AE-99A61AF316AC}" type="datetimeFigureOut">
              <a:rPr lang="fr-FR" smtClean="0"/>
              <a:t>12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B76F22-24AF-4B7D-BD22-745835151E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36716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au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14064579"/>
              </p:ext>
            </p:extLst>
          </p:nvPr>
        </p:nvGraphicFramePr>
        <p:xfrm>
          <a:off x="773430" y="1425005"/>
          <a:ext cx="5311140" cy="3864807"/>
        </p:xfrm>
        <a:graphic>
          <a:graphicData uri="http://schemas.openxmlformats.org/drawingml/2006/table">
            <a:tbl>
              <a:tblPr firstRow="1" firstCol="1" bandRow="1"/>
              <a:tblGrid>
                <a:gridCol w="171069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60045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365125"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able </a:t>
                      </a:r>
                      <a:r>
                        <a:rPr lang="en-US" sz="1200" b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2:</a:t>
                      </a:r>
                      <a:r>
                        <a:rPr lang="en-US" sz="1200" b="1" baseline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200" b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isease </a:t>
                      </a: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ctivity Index (DAI) scoring</a:t>
                      </a:r>
                      <a:endParaRPr lang="fr-FR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2385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ymptom/score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haracteristics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ody weight loss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 loss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-5% loss of body weight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-10% loss of body weight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-20% loss of body weight 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gt;20% loss of body weight 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tool consistency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rmal feces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oose stool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atery diarrhea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limy diarrhea, little blood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evere watery diarrhea with blood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4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lood in stool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 blood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esence of blood assessed by Hemoccult II test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isible </a:t>
                      </a:r>
                      <a:r>
                        <a:rPr lang="fr-FR" sz="12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leeding</a:t>
                      </a:r>
                      <a:endParaRPr lang="fr-FR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341022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407</TotalTime>
  <Words>91</Words>
  <Application>Microsoft Office PowerPoint</Application>
  <PresentationFormat>Affichage à l'écran (4:3)</PresentationFormat>
  <Paragraphs>3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lison AGUS</dc:creator>
  <cp:lastModifiedBy>Allison Agus</cp:lastModifiedBy>
  <cp:revision>237</cp:revision>
  <dcterms:created xsi:type="dcterms:W3CDTF">2016-11-08T08:44:13Z</dcterms:created>
  <dcterms:modified xsi:type="dcterms:W3CDTF">2020-08-12T12:44:45Z</dcterms:modified>
</cp:coreProperties>
</file>